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5E205-568D-4698-91C1-EF238498E9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E572ED-AA92-4D77-B5F5-CD64E40C21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EA4AF1-31AB-419C-B154-4E9C8D46BB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63381-04FF-4179-B414-E8FE2C732B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7C0C8-F193-4DA7-89E2-EA36417799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A0CA0-8217-4B25-850C-F89258D38B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6B35EB-9D89-4582-9BBD-FB5824790A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ACEFC-57BE-4A32-AD44-D1A2EC5C99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C2BE6-6CF6-41E5-BBD2-740139D81E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BA417A-8D0F-44F9-B7C2-20CE55546E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3FC9B3-644D-42D2-A730-ADBDD2D6B5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AFDAD-E36F-48E1-BC6A-4E6DA8D300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6E5E2C-EE87-4ABB-AB9E-44227A684FA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22480" y="2532240"/>
          <a:ext cx="3900240" cy="2250720"/>
        </p:xfrm>
        <a:graphic>
          <a:graphicData uri="http://schemas.openxmlformats.org/drawingml/2006/table">
            <a:tbl>
              <a:tblPr/>
              <a:tblGrid>
                <a:gridCol w="1620720"/>
                <a:gridCol w="658800"/>
                <a:gridCol w="274680"/>
                <a:gridCol w="274680"/>
                <a:gridCol w="274680"/>
                <a:gridCol w="796680"/>
              </a:tblGrid>
              <a:tr h="2095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ilte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tt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eve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S Mea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 rowSpan="3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PPdev Ratio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8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8080">
                <a:tc rowSpan="3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% Inconsistent Allowed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8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9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952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uplicates Allowed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e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8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772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n. Bases Spanned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9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9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2"/>
          <p:cNvSpPr/>
          <p:nvPr/>
        </p:nvSpPr>
        <p:spPr>
          <a:xfrm>
            <a:off x="1055520" y="4768920"/>
            <a:ext cx="3910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vels not connected by same letter are significantly different at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&lt; 0.01,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&lt; 0.0001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3"/>
          <p:cNvSpPr/>
          <p:nvPr/>
        </p:nvSpPr>
        <p:spPr>
          <a:xfrm>
            <a:off x="1030320" y="2259000"/>
            <a:ext cx="336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1. Pairwise T-tests on Data Filtering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3T04:23:23Z</dcterms:created>
  <dc:creator>Theresa Hill</dc:creator>
  <dc:description/>
  <dc:language>en-US</dc:language>
  <cp:lastModifiedBy>Theresa Hill</cp:lastModifiedBy>
  <dcterms:modified xsi:type="dcterms:W3CDTF">2012-03-13T04:28:47Z</dcterms:modified>
  <cp:revision>1</cp:revision>
  <dc:subject/>
  <dc:title>PowerPoint Presentation</dc:title>
</cp:coreProperties>
</file>